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21"/>
  </p:normalViewPr>
  <p:slideViewPr>
    <p:cSldViewPr snapToGrid="0">
      <p:cViewPr varScale="1">
        <p:scale>
          <a:sx n="115" d="100"/>
          <a:sy n="115" d="100"/>
        </p:scale>
        <p:origin x="4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C71F2-EC8D-6567-C165-AEDE9DFF51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E80127-4A53-C78D-603E-403D3FEC4D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38F90E-1E46-C9F8-4BB8-D28CC5EF0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7AEEFB-FE7F-15E6-65DF-813582331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10C1FA-BCAB-F13C-845D-1A48CF1C6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310340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66F3A0-8FA9-F53D-704B-9CF4681E33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764692-A3D0-9B0A-A5E0-7266A13DBC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088DD-4705-8491-FF4E-27DA8072E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939A76-750C-3FD1-CA98-C49687A11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EAB823-A003-65F8-1171-BD183D4EA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54934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0F946C-44E8-76FF-0CCD-86859922E9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722FE9-4020-EF78-8864-840BFAC9FF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8B7F11-1EC1-DE6C-DCEE-29C8D6B1F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C7467C-2DAA-FDF7-8E77-4820ECCDC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82546E-3CB1-83B3-E4F4-7FF8F50C4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65593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3C5028-D2BC-027C-647F-5F0C69004E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05DA15-9837-A866-219F-DAC5A726D8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FC9401-2341-77DD-1C25-32ABF3286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1E12A6-0CB7-D6D6-DAEC-8954D0C08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3A0DCD-2C5B-D26B-E392-3032F65D9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309084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45F36-BF8A-3A33-B95B-0F17B174D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5FFAF0-1079-34CE-A19D-3F20084232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D77D68-9118-6B9B-FD06-E86D51C76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C03F-1457-D06D-8B54-DEC64AEEC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DD253B-D248-511F-A207-D97CFC2DE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03406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3779AB-AEB5-25B9-823D-923AB4835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D0CA65-75A9-C54F-3B4B-B83F839FBF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C52F4D-7A73-2C6A-EF5C-9078974562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1EA435-77A8-7CA9-75EA-17BC0E06D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D25EFF-4642-C385-DE3E-73AB9394A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EDA9BC-658E-D13B-3F11-488E188D6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46884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98BBB-4448-305B-A8D7-E2BA5CDEA7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E584A1-3DD6-FA67-B93F-5A7ABC343C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4D34D8-2EEE-875C-1B19-D4B6CFBAB4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7FED68-32C7-E002-C98D-DE885B4060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0017A62-51BC-740F-21B5-7F5DE31126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3265D9-A7FF-8176-34C5-26BAECB43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7237AD1-83F2-01FA-EC7D-8D07E132DF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F7470F-2D82-33E3-7362-96A007FFE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99910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06AB5F-43E7-FEC7-6E1B-4A25BEA140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0E5239-C0EF-C2F6-319E-64B208854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2D96D2-DF09-F8A0-6563-AD015BC65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DF5C33-9BF9-4AC1-C8D4-95F18624E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233488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7757138-039F-EABF-8DBB-AEE4C61D6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107DE0-192C-AFE8-C093-3C4E01918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7C1FA9-7617-EDEB-9304-477428667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93535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13F9C-1CDC-5419-33C1-D5635D2D3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D9F6A3-C8EE-2CA7-3501-D178740DBA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8CDD81-FF40-D2CC-4F10-8AD6FD8D02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6028EC-2FD3-F41C-8CDB-E234530C5B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F16CBC-96D9-1DB9-EEDA-9F8377614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66C575-E1E5-8B5D-EE8D-BC7EBB80D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70018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8DD3E-19EE-6422-3017-62F4B7AE6C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DC2A5D-8C34-E36A-9743-110A9CE6ED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854C3C-E86C-34B7-9BF0-42AC475FB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DC8210-D166-6801-58E7-CAC5E09B7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82A9E7-D4DF-1451-5E56-3C8F67FF3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FFA7A1-FAA0-6B74-56A0-2C8EA46BC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191652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876DDA9-D747-82FC-C07E-EE85C1ED3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A3BE40-A887-8242-B06E-13C9ADB1EB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9DECD9-26DF-90A6-BABE-101DB5595C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30A9F4-B01F-254B-8838-3007D13974CE}" type="datetimeFigureOut">
              <a:rPr lang="en-JP" smtClean="0"/>
              <a:t>2024/01/05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6E2914-FB14-1D1A-A44A-47498FBCA5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473883-E191-62CD-9E1F-DC35CA3BE8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59CBC-12B3-8C46-B41E-9D8AD3B7BC3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32795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ov"/><Relationship Id="rId7" Type="http://schemas.openxmlformats.org/officeDocument/2006/relationships/image" Target="../media/image2.png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o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SAD3 E2 (x20) (1) 15min_t1 (Converted)" descr="SAD3 E2 (x20) (1) 15min_t1 (Converted)">
            <a:hlinkClick r:id="" action="ppaction://media"/>
            <a:extLst>
              <a:ext uri="{FF2B5EF4-FFF2-40B4-BE49-F238E27FC236}">
                <a16:creationId xmlns:a16="http://schemas.microsoft.com/office/drawing/2014/main" id="{E64B64B5-A526-B2EB-87CE-D62C61B7FB2A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995081" y="1704999"/>
            <a:ext cx="2880000" cy="2880000"/>
          </a:xfrm>
          <a:prstGeom prst="rect">
            <a:avLst/>
          </a:prstGeom>
        </p:spPr>
      </p:pic>
      <p:pic>
        <p:nvPicPr>
          <p:cNvPr id="3" name="SAD3 E2 (x20) (1) 0min_t1 (Converted)" descr="SAD3 E2 (x20) (1) 0min_t1 (Converted)">
            <a:hlinkClick r:id="" action="ppaction://media"/>
            <a:extLst>
              <a:ext uri="{FF2B5EF4-FFF2-40B4-BE49-F238E27FC236}">
                <a16:creationId xmlns:a16="http://schemas.microsoft.com/office/drawing/2014/main" id="{F283319A-3C45-06F9-0CCA-6BB9FDB68868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043037" y="1702625"/>
            <a:ext cx="2880000" cy="2880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9C035CD-4CEB-2646-D3ED-BE0830CA0722}"/>
              </a:ext>
            </a:extLst>
          </p:cNvPr>
          <p:cNvSpPr txBox="1"/>
          <p:nvPr/>
        </p:nvSpPr>
        <p:spPr>
          <a:xfrm>
            <a:off x="235160" y="292858"/>
            <a:ext cx="2380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/>
              <a:t>Supplementary Video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7E62C58-61D7-AA64-0393-1F68B8BA2FD1}"/>
              </a:ext>
            </a:extLst>
          </p:cNvPr>
          <p:cNvSpPr txBox="1"/>
          <p:nvPr/>
        </p:nvSpPr>
        <p:spPr>
          <a:xfrm>
            <a:off x="718909" y="1051905"/>
            <a:ext cx="378630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2500" b="1" dirty="0"/>
              <a:t>A</a:t>
            </a:r>
          </a:p>
        </p:txBody>
      </p:sp>
      <p:sp>
        <p:nvSpPr>
          <p:cNvPr id="8" name="テキスト ボックス 6">
            <a:extLst>
              <a:ext uri="{FF2B5EF4-FFF2-40B4-BE49-F238E27FC236}">
                <a16:creationId xmlns:a16="http://schemas.microsoft.com/office/drawing/2014/main" id="{08887B80-D37A-1BCA-5415-853E3A9DC6E8}"/>
              </a:ext>
            </a:extLst>
          </p:cNvPr>
          <p:cNvSpPr txBox="1"/>
          <p:nvPr/>
        </p:nvSpPr>
        <p:spPr>
          <a:xfrm>
            <a:off x="5470722" y="4831894"/>
            <a:ext cx="192873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500" dirty="0">
                <a:latin typeface="Helvetica" pitchFamily="2" charset="0"/>
              </a:rPr>
              <a:t>15 min after </a:t>
            </a:r>
          </a:p>
          <a:p>
            <a:pPr algn="ctr"/>
            <a:r>
              <a:rPr lang="en-US" altLang="ja-JP" sz="1500" dirty="0">
                <a:latin typeface="Helvetica" pitchFamily="2" charset="0"/>
              </a:rPr>
              <a:t>100nM E2 treatment</a:t>
            </a:r>
          </a:p>
        </p:txBody>
      </p:sp>
      <p:sp>
        <p:nvSpPr>
          <p:cNvPr id="9" name="テキスト ボックス 6">
            <a:extLst>
              <a:ext uri="{FF2B5EF4-FFF2-40B4-BE49-F238E27FC236}">
                <a16:creationId xmlns:a16="http://schemas.microsoft.com/office/drawing/2014/main" id="{C8DF365F-AAE4-8A1F-E41D-80EE8167609F}"/>
              </a:ext>
            </a:extLst>
          </p:cNvPr>
          <p:cNvSpPr txBox="1"/>
          <p:nvPr/>
        </p:nvSpPr>
        <p:spPr>
          <a:xfrm>
            <a:off x="2155064" y="4947311"/>
            <a:ext cx="65594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500" dirty="0">
                <a:latin typeface="Helvetica" pitchFamily="2" charset="0"/>
              </a:rPr>
              <a:t>0 min</a:t>
            </a:r>
            <a:endParaRPr kumimoji="1" lang="ja-JP" altLang="en-US" sz="1500">
              <a:latin typeface="Helvetica" pitchFamily="2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5711E6-08FE-F790-CB3A-56C06DAE9943}"/>
              </a:ext>
            </a:extLst>
          </p:cNvPr>
          <p:cNvSpPr txBox="1"/>
          <p:nvPr/>
        </p:nvSpPr>
        <p:spPr>
          <a:xfrm>
            <a:off x="1043037" y="5623060"/>
            <a:ext cx="6832044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Video 1</a:t>
            </a:r>
            <a:r>
              <a:rPr lang="en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JP" sz="1100" b="1" kern="100" dirty="0"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sz="1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2 treatment to the iPSC-derived neurons (healthy control 1210B2 line (WT1)) resulted in an increased Ca</a:t>
            </a:r>
            <a:r>
              <a:rPr lang="en-US" sz="1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scillation measured by Ca</a:t>
            </a:r>
            <a:r>
              <a:rPr lang="en-US" sz="1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maging using Fluo-8 indicator before (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after 15-min (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treatment.</a:t>
            </a:r>
            <a:r>
              <a:rPr lang="en-JP" sz="11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JP" sz="1100" kern="1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21A1817-1B35-C587-BBF0-31F93B1500AC}"/>
              </a:ext>
            </a:extLst>
          </p:cNvPr>
          <p:cNvSpPr txBox="1"/>
          <p:nvPr/>
        </p:nvSpPr>
        <p:spPr>
          <a:xfrm>
            <a:off x="4680571" y="1051905"/>
            <a:ext cx="36420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25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510727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6000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60</Words>
  <Application>Microsoft Macintosh PowerPoint</Application>
  <PresentationFormat>Widescreen</PresentationFormat>
  <Paragraphs>7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スパグン ソパック</dc:creator>
  <cp:lastModifiedBy>スパグン ソパック</cp:lastModifiedBy>
  <cp:revision>4</cp:revision>
  <dcterms:created xsi:type="dcterms:W3CDTF">2023-08-26T06:15:52Z</dcterms:created>
  <dcterms:modified xsi:type="dcterms:W3CDTF">2024-01-05T05:57:24Z</dcterms:modified>
</cp:coreProperties>
</file>